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535" r:id="rId2"/>
    <p:sldId id="496" r:id="rId3"/>
    <p:sldId id="486" r:id="rId4"/>
    <p:sldId id="48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52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F66B3E-5865-4BCF-8324-E52B496142D3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3DF903-15BF-4197-A0F3-3B9708EDE7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185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7E184B0-DC4C-44CB-A883-3D14F91BB9CD}" type="slidenum">
              <a:rPr lang="en-US" altLang="ja-JP" smtClean="0"/>
              <a:t>2</a:t>
            </a:fld>
            <a:endParaRPr lang="en-US" altLang="ja-JP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7E184B0-DC4C-44CB-A883-3D14F91BB9CD}" type="slidenum">
              <a:rPr lang="en-US" altLang="ja-JP" smtClean="0"/>
              <a:t>4</a:t>
            </a:fld>
            <a:endParaRPr lang="en-US" altLang="ja-JP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A6B5F1-5D52-9FC7-2144-A9F4BB1D2F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FF8759-7D93-7BA7-3796-FC80CD8E79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BE8222-E470-EDE0-D950-37C63781E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F0508D-2559-4412-2B75-E3EAF373E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28F0DC-ACAA-D94F-C0AF-3FB7303080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714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BFDA38-7365-AF03-7D22-56494A6E8A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FE4510-4DA6-4694-A3E1-A53B20F093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80EB99-C1B8-7ADA-8FB5-9657961BF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08D6FC-7669-1D0D-97D9-CFDFA33BC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042B22-C6A5-D36F-3016-AE4708516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205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DA4E11-E6E3-7D8D-4894-C804C16633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26DD78-C56E-7C6F-ADF1-105A1675A2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C0A91C-7516-CB64-F86C-00C88AB15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533575-3F2C-2D74-2990-5D68F4EFC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223DAC-97C1-5C4D-03C1-D2B9784761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858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9BE33F-BD5C-AF00-4241-D5D5F10C9B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B368EA-1582-C2E7-BC39-F7614DD1CB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3D6060-EDAB-B3CA-1383-DA3162341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AE2080-70F4-93F4-089E-66F80FC79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550AF6-B9E3-16E6-59DD-02F00428B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64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7EA1EB-8E60-5A36-E06C-0700898E94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2E9666-8A6E-184B-6FE8-827E831904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A2978E-A1AD-8CF5-120A-2365C23B2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B31C25-A1A7-D51C-D33A-23706A1E1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BF4E49-63B4-A95F-2DB4-3CA6263D48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332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26D2F0-E4A2-E01E-7080-866273BDD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79760A-FEB6-CEDC-34CB-D9F8319A6F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B673AB-54E6-7EEF-85F0-BC74627A3D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205D39-85D5-6B94-D248-09B262675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9B58-DFDD-7DC3-E425-917977C45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4571D7-74B8-DB93-E40E-CD93CB28F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841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6CB5D9-8173-8BD7-A0EF-6E97370CD5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1E511F-0E48-CA70-7452-2448A0D1B3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5551CD-1D87-341A-B531-0C1458BFD4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7FB8015-EEE8-71AE-978F-EB6043FAD0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502D9-52E3-AE71-44AE-6394FD16F4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41074B4-359B-D7D3-62E7-C3FEC812C1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497A9D7-018E-179E-CCE0-EE59A0D7D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C0E4B3-2DCF-E47F-421E-10CB3ED365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75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8AFC5F-C88D-C159-BB66-5D6ABE9BF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EFCEC0B-7336-3C8C-26C3-53404F7ED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CC3DBCF-7DC7-CCE7-86D7-8F2902E7A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34F4BF4-2539-9116-2EFD-01F048711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742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DDBC13-B019-363C-CBB0-01C186897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BE22708-D16A-2E93-0990-D592B521F5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42E2DC-5C6B-A8A1-9DC8-7D17FB566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731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17AD3-EB1A-03D6-10AB-B5AB964B80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D1DB86-36FF-7256-6281-55775572B8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93DFA8-95BD-6FD2-B882-B259A33B89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1CECCC-338B-D167-8A90-C8A72639E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16A75B-D2DB-8FDB-4486-30174CE7C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8CBBDA-EED9-4121-F3F7-DEEC9A2C4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71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FC9E1-416B-869C-FAF1-C865328C16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A6BD4F-9B3B-E520-EDEE-80F3BA12DC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50A4EB-5F1A-F5B7-8A44-752C4D38B6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67696E-3082-2F89-12A8-82F64E589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A9D637-AD6D-3A69-5DCE-28C5DD6611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5B6F8C-E570-130F-EDC1-FBC6768E22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54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C3564CE-4D27-1C13-7DF3-32DE84F751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431D84-215C-31C7-4D27-42DE88BD0A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A70B04-41B7-D479-6801-D0642ABC71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9890D-3DD1-4516-8040-43DE2721CE17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2C05B4-4644-108C-321D-7A4205EA93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98F29A-9AE7-FA49-62AB-7660FC265E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E4C72-36F7-4711-B0FC-BC4C0830C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392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tiff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9.jpeg"/><Relationship Id="rId7" Type="http://schemas.microsoft.com/office/2007/relationships/hdphoto" Target="../media/hdphoto4.wdp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jpeg"/><Relationship Id="rId4" Type="http://schemas.openxmlformats.org/officeDocument/2006/relationships/image" Target="../media/image10.jpeg"/><Relationship Id="rId9" Type="http://schemas.microsoft.com/office/2007/relationships/hdphoto" Target="../media/hdphoto5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3" Type="http://schemas.openxmlformats.org/officeDocument/2006/relationships/image" Target="../media/image14.jpe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microsoft.com/office/2007/relationships/hdphoto" Target="../media/hdphoto6.wdp"/><Relationship Id="rId5" Type="http://schemas.openxmlformats.org/officeDocument/2006/relationships/image" Target="../media/image16.png"/><Relationship Id="rId4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1615424" y="4037748"/>
            <a:ext cx="9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5b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0" y="97696"/>
            <a:ext cx="6618875" cy="3332588"/>
            <a:chOff x="1525134" y="1052736"/>
            <a:chExt cx="6618875" cy="3332588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418" t="55649" r="38024" b="41359"/>
            <a:stretch>
              <a:fillRect/>
            </a:stretch>
          </p:blipFill>
          <p:spPr>
            <a:xfrm>
              <a:off x="2315005" y="2022359"/>
              <a:ext cx="3596898" cy="644149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sp>
          <p:nvSpPr>
            <p:cNvPr id="5" name="TextBox 4"/>
            <p:cNvSpPr txBox="1"/>
            <p:nvPr/>
          </p:nvSpPr>
          <p:spPr>
            <a:xfrm>
              <a:off x="6017869" y="2116363"/>
              <a:ext cx="15504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017869" y="2996952"/>
              <a:ext cx="19437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017869" y="3805407"/>
              <a:ext cx="21261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amin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 A/C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294182" y="1052736"/>
              <a:ext cx="14137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whole cell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634222" y="1056702"/>
              <a:ext cx="10856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ytosol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825554" y="1066994"/>
              <a:ext cx="10863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nucleus</a:t>
              </a:r>
            </a:p>
          </p:txBody>
        </p:sp>
        <p:cxnSp>
          <p:nvCxnSpPr>
            <p:cNvPr id="13" name="Straight Connector 12"/>
            <p:cNvCxnSpPr/>
            <p:nvPr/>
          </p:nvCxnSpPr>
          <p:spPr>
            <a:xfrm>
              <a:off x="4810811" y="1512639"/>
              <a:ext cx="1027685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2123728" y="1577096"/>
              <a:ext cx="14503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U87 </a:t>
              </a:r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GC</a:t>
              </a:r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432489" y="1577096"/>
              <a:ext cx="15116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U87 </a:t>
              </a:r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GC</a:t>
              </a:r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719864" y="1577096"/>
              <a:ext cx="16117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U87 </a:t>
              </a:r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GC</a:t>
              </a:r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pic>
          <p:nvPicPr>
            <p:cNvPr id="17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27" t="15120" r="16911" b="22188"/>
            <a:stretch>
              <a:fillRect/>
            </a:stretch>
          </p:blipFill>
          <p:spPr bwMode="auto">
            <a:xfrm>
              <a:off x="2315005" y="2913848"/>
              <a:ext cx="3596898" cy="648072"/>
            </a:xfrm>
            <a:prstGeom prst="rect">
              <a:avLst/>
            </a:prstGeom>
            <a:noFill/>
            <a:ln w="254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4" name="Picture 5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999" t="77450" r="28356" b="19572"/>
            <a:stretch>
              <a:fillRect/>
            </a:stretch>
          </p:blipFill>
          <p:spPr>
            <a:xfrm>
              <a:off x="2315006" y="3746628"/>
              <a:ext cx="3596898" cy="638696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cxnSp>
          <p:nvCxnSpPr>
            <p:cNvPr id="56" name="Straight Connector 55"/>
            <p:cNvCxnSpPr/>
            <p:nvPr/>
          </p:nvCxnSpPr>
          <p:spPr>
            <a:xfrm flipV="1">
              <a:off x="3562908" y="1512639"/>
              <a:ext cx="1027685" cy="174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 flipV="1">
              <a:off x="2388410" y="1512639"/>
              <a:ext cx="1044078" cy="174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>
              <a:off x="1964074" y="4174739"/>
              <a:ext cx="2324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1525134" y="3990073"/>
              <a:ext cx="4823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72</a:t>
              </a:r>
            </a:p>
          </p:txBody>
        </p:sp>
        <p:cxnSp>
          <p:nvCxnSpPr>
            <p:cNvPr id="66" name="Straight Connector 65"/>
            <p:cNvCxnSpPr/>
            <p:nvPr/>
          </p:nvCxnSpPr>
          <p:spPr>
            <a:xfrm>
              <a:off x="1986187" y="3366060"/>
              <a:ext cx="2324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/>
            <p:cNvSpPr txBox="1"/>
            <p:nvPr/>
          </p:nvSpPr>
          <p:spPr>
            <a:xfrm>
              <a:off x="1547247" y="3181394"/>
              <a:ext cx="4823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55</a:t>
              </a:r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2007520" y="2348880"/>
              <a:ext cx="2324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/>
            <p:cNvSpPr txBox="1"/>
            <p:nvPr/>
          </p:nvSpPr>
          <p:spPr>
            <a:xfrm>
              <a:off x="1547664" y="2132856"/>
              <a:ext cx="4823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55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532927" y="1691516"/>
              <a:ext cx="6496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" name="Picture 3" descr="A picture containing calendar&#10;&#10;Description automatically generated">
            <a:extLst>
              <a:ext uri="{FF2B5EF4-FFF2-40B4-BE49-F238E27FC236}">
                <a16:creationId xmlns:a16="http://schemas.microsoft.com/office/drawing/2014/main" id="{B2A153F2-C08C-2EF9-29D1-7D1617E04937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865" b="23182"/>
          <a:stretch/>
        </p:blipFill>
        <p:spPr>
          <a:xfrm>
            <a:off x="7427327" y="130876"/>
            <a:ext cx="3881964" cy="5963383"/>
          </a:xfrm>
          <a:prstGeom prst="rect">
            <a:avLst/>
          </a:prstGeom>
        </p:spPr>
      </p:pic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AD952400-8C78-94DA-6F96-537071A647A4}"/>
              </a:ext>
            </a:extLst>
          </p:cNvPr>
          <p:cNvCxnSpPr>
            <a:cxnSpLocks/>
          </p:cNvCxnSpPr>
          <p:nvPr/>
        </p:nvCxnSpPr>
        <p:spPr>
          <a:xfrm>
            <a:off x="5266156" y="1389393"/>
            <a:ext cx="1659687" cy="26911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5032155-BCDE-E5CD-09F7-B6E9BCA45A12}"/>
              </a:ext>
            </a:extLst>
          </p:cNvPr>
          <p:cNvCxnSpPr>
            <a:cxnSpLocks/>
          </p:cNvCxnSpPr>
          <p:nvPr/>
        </p:nvCxnSpPr>
        <p:spPr>
          <a:xfrm>
            <a:off x="5762001" y="2255718"/>
            <a:ext cx="1512346" cy="2356922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4D1D6E38-DCF5-BC96-CCF0-0D68B7010D7C}"/>
              </a:ext>
            </a:extLst>
          </p:cNvPr>
          <p:cNvCxnSpPr>
            <a:cxnSpLocks/>
          </p:cNvCxnSpPr>
          <p:nvPr/>
        </p:nvCxnSpPr>
        <p:spPr>
          <a:xfrm>
            <a:off x="5795934" y="3035033"/>
            <a:ext cx="1645881" cy="0"/>
          </a:xfrm>
          <a:prstGeom prst="straightConnector1">
            <a:avLst/>
          </a:prstGeom>
          <a:ln w="25400">
            <a:solidFill>
              <a:schemeClr val="accent4">
                <a:lumMod val="75000"/>
              </a:schemeClr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DD302AE3-06A6-85AB-1A05-B1FB71D68DC8}"/>
              </a:ext>
            </a:extLst>
          </p:cNvPr>
          <p:cNvSpPr txBox="1"/>
          <p:nvPr/>
        </p:nvSpPr>
        <p:spPr>
          <a:xfrm>
            <a:off x="6518174" y="6167120"/>
            <a:ext cx="4952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Western Blot picture for Fig. 5b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248106" y="3059668"/>
            <a:ext cx="9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6b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437376" y="1194220"/>
            <a:ext cx="3096344" cy="1546406"/>
            <a:chOff x="5436096" y="802149"/>
            <a:chExt cx="3096344" cy="1546406"/>
          </a:xfrm>
        </p:grpSpPr>
        <p:sp>
          <p:nvSpPr>
            <p:cNvPr id="27" name="TextBox 26"/>
            <p:cNvSpPr txBox="1"/>
            <p:nvPr/>
          </p:nvSpPr>
          <p:spPr>
            <a:xfrm>
              <a:off x="7524328" y="1281951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7494204" y="1835532"/>
              <a:ext cx="10382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32" name="TextBox 6"/>
            <p:cNvSpPr txBox="1">
              <a:spLocks noChangeArrowheads="1"/>
            </p:cNvSpPr>
            <p:nvPr/>
          </p:nvSpPr>
          <p:spPr bwMode="auto">
            <a:xfrm>
              <a:off x="6263562" y="802149"/>
              <a:ext cx="612694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87</a:t>
              </a:r>
            </a:p>
          </p:txBody>
        </p:sp>
        <p:sp>
          <p:nvSpPr>
            <p:cNvPr id="33" name="TextBox 7"/>
            <p:cNvSpPr txBox="1">
              <a:spLocks noChangeArrowheads="1"/>
            </p:cNvSpPr>
            <p:nvPr/>
          </p:nvSpPr>
          <p:spPr bwMode="auto">
            <a:xfrm>
              <a:off x="6772977" y="802150"/>
              <a:ext cx="95125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GC</a:t>
              </a:r>
              <a:r>
                <a:rPr lang="el-GR" altLang="en-US" sz="18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en-US" sz="18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pic>
          <p:nvPicPr>
            <p:cNvPr id="37" name="Picture 36"/>
            <p:cNvPicPr>
              <a:picLocks noChangeAspect="1"/>
            </p:cNvPicPr>
            <p:nvPr/>
          </p:nvPicPr>
          <p:blipFill rotWithShape="1">
            <a:blip r:embed="rId3"/>
            <a:srcRect l="33301" t="21735" r="910" b="8240"/>
            <a:stretch>
              <a:fillRect/>
            </a:stretch>
          </p:blipFill>
          <p:spPr>
            <a:xfrm>
              <a:off x="6217391" y="1299590"/>
              <a:ext cx="1205147" cy="388573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 rotWithShape="1">
            <a:blip r:embed="rId4"/>
            <a:srcRect l="34569" t="10753" r="3490" b="4429"/>
            <a:stretch>
              <a:fillRect/>
            </a:stretch>
          </p:blipFill>
          <p:spPr>
            <a:xfrm>
              <a:off x="6217392" y="1853171"/>
              <a:ext cx="1242142" cy="400501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cxnSp>
          <p:nvCxnSpPr>
            <p:cNvPr id="34" name="Straight Connector 33"/>
            <p:cNvCxnSpPr/>
            <p:nvPr/>
          </p:nvCxnSpPr>
          <p:spPr>
            <a:xfrm>
              <a:off x="5900055" y="1280055"/>
              <a:ext cx="2324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5900055" y="1639102"/>
              <a:ext cx="2324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/>
            <p:cNvSpPr txBox="1"/>
            <p:nvPr/>
          </p:nvSpPr>
          <p:spPr>
            <a:xfrm>
              <a:off x="5445579" y="1115452"/>
              <a:ext cx="5578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26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436096" y="1412776"/>
              <a:ext cx="4823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17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445579" y="832433"/>
              <a:ext cx="728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err="1"/>
                <a:t>kDa</a:t>
              </a:r>
              <a:endParaRPr lang="en-US" b="1" dirty="0"/>
            </a:p>
          </p:txBody>
        </p:sp>
        <p:cxnSp>
          <p:nvCxnSpPr>
            <p:cNvPr id="40" name="Straight Connector 39"/>
            <p:cNvCxnSpPr/>
            <p:nvPr/>
          </p:nvCxnSpPr>
          <p:spPr>
            <a:xfrm>
              <a:off x="5891755" y="1850723"/>
              <a:ext cx="2324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>
              <a:off x="5900055" y="2163889"/>
              <a:ext cx="2324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5436096" y="1691516"/>
              <a:ext cx="5578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55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436096" y="1979223"/>
              <a:ext cx="4823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42</a:t>
              </a:r>
            </a:p>
          </p:txBody>
        </p:sp>
      </p:grpSp>
      <p:pic>
        <p:nvPicPr>
          <p:cNvPr id="3" name="Picture 2" descr="A picture containing text, receipt&#10;&#10;Description automatically generated">
            <a:extLst>
              <a:ext uri="{FF2B5EF4-FFF2-40B4-BE49-F238E27FC236}">
                <a16:creationId xmlns:a16="http://schemas.microsoft.com/office/drawing/2014/main" id="{2DAAEAEF-AEF0-24EB-D53A-FC9BD8F1D3A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575"/>
          <a:stretch/>
        </p:blipFill>
        <p:spPr>
          <a:xfrm>
            <a:off x="5791200" y="858122"/>
            <a:ext cx="5397381" cy="2346101"/>
          </a:xfrm>
          <a:prstGeom prst="rect">
            <a:avLst/>
          </a:prstGeom>
        </p:spPr>
      </p:pic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5302D3E8-C6F4-BACD-871C-5882FCA8A71C}"/>
              </a:ext>
            </a:extLst>
          </p:cNvPr>
          <p:cNvCxnSpPr>
            <a:cxnSpLocks/>
          </p:cNvCxnSpPr>
          <p:nvPr/>
        </p:nvCxnSpPr>
        <p:spPr>
          <a:xfrm>
            <a:off x="3490700" y="1857572"/>
            <a:ext cx="2300500" cy="698388"/>
          </a:xfrm>
          <a:prstGeom prst="straightConnector1">
            <a:avLst/>
          </a:prstGeom>
          <a:ln w="25400">
            <a:solidFill>
              <a:srgbClr val="FFFF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79CD687-DFC3-8541-349A-A139FB41E52E}"/>
              </a:ext>
            </a:extLst>
          </p:cNvPr>
          <p:cNvCxnSpPr>
            <a:cxnSpLocks/>
          </p:cNvCxnSpPr>
          <p:nvPr/>
        </p:nvCxnSpPr>
        <p:spPr>
          <a:xfrm flipV="1">
            <a:off x="3598278" y="2174179"/>
            <a:ext cx="2365926" cy="27874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Rectangle 52">
            <a:extLst>
              <a:ext uri="{FF2B5EF4-FFF2-40B4-BE49-F238E27FC236}">
                <a16:creationId xmlns:a16="http://schemas.microsoft.com/office/drawing/2014/main" id="{8F21F14F-1F02-818B-6304-D5105AD3B1B3}"/>
              </a:ext>
            </a:extLst>
          </p:cNvPr>
          <p:cNvSpPr/>
          <p:nvPr/>
        </p:nvSpPr>
        <p:spPr>
          <a:xfrm>
            <a:off x="7645237" y="2596935"/>
            <a:ext cx="548640" cy="274320"/>
          </a:xfrm>
          <a:prstGeom prst="rect">
            <a:avLst/>
          </a:prstGeom>
          <a:noFill/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07078028-04F9-F936-462A-625AB12EA203}"/>
              </a:ext>
            </a:extLst>
          </p:cNvPr>
          <p:cNvSpPr/>
          <p:nvPr/>
        </p:nvSpPr>
        <p:spPr>
          <a:xfrm>
            <a:off x="7709802" y="2080234"/>
            <a:ext cx="548640" cy="27432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818575A-3627-E951-77E0-0BDFEE151D1E}"/>
              </a:ext>
            </a:extLst>
          </p:cNvPr>
          <p:cNvSpPr txBox="1"/>
          <p:nvPr/>
        </p:nvSpPr>
        <p:spPr>
          <a:xfrm>
            <a:off x="6772174" y="4660868"/>
            <a:ext cx="495246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Western Blot picture for Fig. 6b</a:t>
            </a:r>
          </a:p>
          <a:p>
            <a:r>
              <a:rPr lang="en-US" dirty="0"/>
              <a:t>Note that the staining intensity of the actin bands was used to normalize the data on the levels of p53 expression shown in Figure 5c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1028476" y="2061451"/>
            <a:ext cx="9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6e</a:t>
            </a:r>
          </a:p>
        </p:txBody>
      </p:sp>
      <p:pic>
        <p:nvPicPr>
          <p:cNvPr id="12" name="Picture 11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54724AE2-1D33-8E73-8619-7A84B687413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73" t="52326" b="11570"/>
          <a:stretch/>
        </p:blipFill>
        <p:spPr>
          <a:xfrm>
            <a:off x="6402776" y="2707231"/>
            <a:ext cx="3963391" cy="2628167"/>
          </a:xfrm>
          <a:prstGeom prst="rect">
            <a:avLst/>
          </a:prstGeom>
        </p:spPr>
      </p:pic>
      <p:pic>
        <p:nvPicPr>
          <p:cNvPr id="20" name="Picture 19" descr="Letter, calendar&#10;&#10;Description automatically generated">
            <a:extLst>
              <a:ext uri="{FF2B5EF4-FFF2-40B4-BE49-F238E27FC236}">
                <a16:creationId xmlns:a16="http://schemas.microsoft.com/office/drawing/2014/main" id="{B82D13ED-946B-F442-172B-C35E03A6847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5" r="6672" b="74225"/>
          <a:stretch/>
        </p:blipFill>
        <p:spPr>
          <a:xfrm>
            <a:off x="66296" y="3890863"/>
            <a:ext cx="5071633" cy="2474372"/>
          </a:xfrm>
          <a:prstGeom prst="rect">
            <a:avLst/>
          </a:prstGeom>
        </p:spPr>
      </p:pic>
      <p:pic>
        <p:nvPicPr>
          <p:cNvPr id="22" name="Picture 21" descr="Text, letter&#10;&#10;Description automatically generated">
            <a:extLst>
              <a:ext uri="{FF2B5EF4-FFF2-40B4-BE49-F238E27FC236}">
                <a16:creationId xmlns:a16="http://schemas.microsoft.com/office/drawing/2014/main" id="{024D8E2D-5CD1-D9F4-20B8-F633F7883F7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32" t="11089" r="16501" b="62678"/>
          <a:stretch/>
        </p:blipFill>
        <p:spPr>
          <a:xfrm>
            <a:off x="5864739" y="31859"/>
            <a:ext cx="3967386" cy="2138774"/>
          </a:xfrm>
          <a:prstGeom prst="rect">
            <a:avLst/>
          </a:prstGeom>
        </p:spPr>
      </p:pic>
      <p:grpSp>
        <p:nvGrpSpPr>
          <p:cNvPr id="26" name="Group 25">
            <a:extLst>
              <a:ext uri="{FF2B5EF4-FFF2-40B4-BE49-F238E27FC236}">
                <a16:creationId xmlns:a16="http://schemas.microsoft.com/office/drawing/2014/main" id="{13BAAC3B-EFF5-06B7-4522-AD5B60144511}"/>
              </a:ext>
            </a:extLst>
          </p:cNvPr>
          <p:cNvGrpSpPr/>
          <p:nvPr/>
        </p:nvGrpSpPr>
        <p:grpSpPr>
          <a:xfrm>
            <a:off x="143312" y="36572"/>
            <a:ext cx="3006288" cy="1990605"/>
            <a:chOff x="143313" y="1023537"/>
            <a:chExt cx="3006288" cy="1990605"/>
          </a:xfrm>
        </p:grpSpPr>
        <p:sp>
          <p:nvSpPr>
            <p:cNvPr id="113671" name="TextBox 1"/>
            <p:cNvSpPr txBox="1">
              <a:spLocks noChangeArrowheads="1"/>
            </p:cNvSpPr>
            <p:nvPr/>
          </p:nvSpPr>
          <p:spPr bwMode="auto">
            <a:xfrm>
              <a:off x="2128777" y="1961034"/>
              <a:ext cx="983603" cy="3680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K6</a:t>
              </a:r>
            </a:p>
          </p:txBody>
        </p:sp>
        <p:sp>
          <p:nvSpPr>
            <p:cNvPr id="113672" name="TextBox 6"/>
            <p:cNvSpPr txBox="1">
              <a:spLocks noChangeArrowheads="1"/>
            </p:cNvSpPr>
            <p:nvPr/>
          </p:nvSpPr>
          <p:spPr bwMode="auto">
            <a:xfrm>
              <a:off x="841601" y="1023537"/>
              <a:ext cx="63691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87</a:t>
              </a:r>
            </a:p>
          </p:txBody>
        </p:sp>
        <p:sp>
          <p:nvSpPr>
            <p:cNvPr id="113673" name="TextBox 7"/>
            <p:cNvSpPr txBox="1">
              <a:spLocks noChangeArrowheads="1"/>
            </p:cNvSpPr>
            <p:nvPr/>
          </p:nvSpPr>
          <p:spPr bwMode="auto">
            <a:xfrm>
              <a:off x="1505754" y="1023538"/>
              <a:ext cx="93094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GC</a:t>
              </a:r>
              <a:r>
                <a:rPr lang="el-GR" altLang="en-US" sz="18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en-US" sz="18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13674" name="TextBox 12"/>
            <p:cNvSpPr txBox="1">
              <a:spLocks noChangeArrowheads="1"/>
            </p:cNvSpPr>
            <p:nvPr/>
          </p:nvSpPr>
          <p:spPr bwMode="auto">
            <a:xfrm>
              <a:off x="2128777" y="1479729"/>
              <a:ext cx="983603" cy="3696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0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K4</a:t>
              </a:r>
            </a:p>
          </p:txBody>
        </p:sp>
        <p:sp>
          <p:nvSpPr>
            <p:cNvPr id="113679" name="TextBox 3"/>
            <p:cNvSpPr txBox="1">
              <a:spLocks noChangeArrowheads="1"/>
            </p:cNvSpPr>
            <p:nvPr/>
          </p:nvSpPr>
          <p:spPr bwMode="auto">
            <a:xfrm>
              <a:off x="2128777" y="2474725"/>
              <a:ext cx="1020824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l-GR" altLang="en-US" sz="18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en-US" sz="18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cxnSp>
          <p:nvCxnSpPr>
            <p:cNvPr id="33" name="Straight Connector 32"/>
            <p:cNvCxnSpPr/>
            <p:nvPr/>
          </p:nvCxnSpPr>
          <p:spPr>
            <a:xfrm>
              <a:off x="539283" y="1547913"/>
              <a:ext cx="23080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539283" y="2051969"/>
              <a:ext cx="23080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148022" y="1835945"/>
              <a:ext cx="4790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42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43313" y="1033862"/>
              <a:ext cx="723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err="1"/>
                <a:t>kDa</a:t>
              </a:r>
              <a:endParaRPr lang="en-US" b="1" dirty="0"/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531040" y="2484017"/>
              <a:ext cx="23080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539283" y="2844057"/>
              <a:ext cx="23080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144616" y="2267993"/>
              <a:ext cx="4777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55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48022" y="2644810"/>
              <a:ext cx="4790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42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43313" y="1344058"/>
              <a:ext cx="4790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42</a:t>
              </a:r>
            </a:p>
          </p:txBody>
        </p:sp>
        <p:pic>
          <p:nvPicPr>
            <p:cNvPr id="21" name="Picture 20" descr="A picture containing graphical user interface&#10;&#10;Description automatically generated">
              <a:extLst>
                <a:ext uri="{FF2B5EF4-FFF2-40B4-BE49-F238E27FC236}">
                  <a16:creationId xmlns:a16="http://schemas.microsoft.com/office/drawing/2014/main" id="{15A64731-CD30-501B-234E-9A749DD32E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253" t="74698" r="48296" b="23592"/>
            <a:stretch/>
          </p:blipFill>
          <p:spPr>
            <a:xfrm>
              <a:off x="896787" y="1936784"/>
              <a:ext cx="1234981" cy="346154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pic>
          <p:nvPicPr>
            <p:cNvPr id="23" name="Picture 22" descr="Text, letter&#10;&#10;Description automatically generated">
              <a:extLst>
                <a:ext uri="{FF2B5EF4-FFF2-40B4-BE49-F238E27FC236}">
                  <a16:creationId xmlns:a16="http://schemas.microsoft.com/office/drawing/2014/main" id="{E60D8C77-455A-C7F9-479F-25D7E79B30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68" t="33707" r="60671" b="64295"/>
            <a:stretch/>
          </p:blipFill>
          <p:spPr>
            <a:xfrm>
              <a:off x="884126" y="1379853"/>
              <a:ext cx="1243256" cy="411899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pic>
          <p:nvPicPr>
            <p:cNvPr id="25" name="Picture 24" descr="Letter, calendar&#10;&#10;Description automatically generated">
              <a:extLst>
                <a:ext uri="{FF2B5EF4-FFF2-40B4-BE49-F238E27FC236}">
                  <a16:creationId xmlns:a16="http://schemas.microsoft.com/office/drawing/2014/main" id="{71A63CD4-9F19-5886-7A21-2E4F8C52D8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401" t="13514" r="52588" b="84718"/>
            <a:stretch/>
          </p:blipFill>
          <p:spPr>
            <a:xfrm>
              <a:off x="873155" y="2427970"/>
              <a:ext cx="1276816" cy="387605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</p:grpSp>
      <p:sp>
        <p:nvSpPr>
          <p:cNvPr id="29" name="Rectangle 28">
            <a:extLst>
              <a:ext uri="{FF2B5EF4-FFF2-40B4-BE49-F238E27FC236}">
                <a16:creationId xmlns:a16="http://schemas.microsoft.com/office/drawing/2014/main" id="{E483525A-4C2D-AD75-3706-05FAE47B2E38}"/>
              </a:ext>
            </a:extLst>
          </p:cNvPr>
          <p:cNvSpPr/>
          <p:nvPr/>
        </p:nvSpPr>
        <p:spPr>
          <a:xfrm>
            <a:off x="7299792" y="4294895"/>
            <a:ext cx="548640" cy="274320"/>
          </a:xfrm>
          <a:prstGeom prst="rect">
            <a:avLst/>
          </a:prstGeom>
          <a:noFill/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1DFF41BF-A0F3-CD9A-3A0D-8ACAEB652D79}"/>
              </a:ext>
            </a:extLst>
          </p:cNvPr>
          <p:cNvSpPr/>
          <p:nvPr/>
        </p:nvSpPr>
        <p:spPr>
          <a:xfrm>
            <a:off x="6709903" y="1784719"/>
            <a:ext cx="548640" cy="27432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3CA8230D-2456-A011-FC4D-BF62A68F3F73}"/>
              </a:ext>
            </a:extLst>
          </p:cNvPr>
          <p:cNvCxnSpPr>
            <a:stCxn id="113674" idx="3"/>
          </p:cNvCxnSpPr>
          <p:nvPr/>
        </p:nvCxnSpPr>
        <p:spPr>
          <a:xfrm>
            <a:off x="3112379" y="677566"/>
            <a:ext cx="2699141" cy="296503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8AB8264D-1FD8-FC19-33C6-B29A15F5936D}"/>
              </a:ext>
            </a:extLst>
          </p:cNvPr>
          <p:cNvCxnSpPr>
            <a:cxnSpLocks/>
            <a:stCxn id="113671" idx="3"/>
          </p:cNvCxnSpPr>
          <p:nvPr/>
        </p:nvCxnSpPr>
        <p:spPr>
          <a:xfrm>
            <a:off x="3112379" y="1158078"/>
            <a:ext cx="3281172" cy="2943602"/>
          </a:xfrm>
          <a:prstGeom prst="straightConnector1">
            <a:avLst/>
          </a:prstGeom>
          <a:ln w="2540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3E982109-08DA-DFF4-DF21-671F92DEEFB6}"/>
              </a:ext>
            </a:extLst>
          </p:cNvPr>
          <p:cNvCxnSpPr/>
          <p:nvPr/>
        </p:nvCxnSpPr>
        <p:spPr>
          <a:xfrm>
            <a:off x="1625600" y="2994086"/>
            <a:ext cx="0" cy="1313754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45">
            <a:extLst>
              <a:ext uri="{FF2B5EF4-FFF2-40B4-BE49-F238E27FC236}">
                <a16:creationId xmlns:a16="http://schemas.microsoft.com/office/drawing/2014/main" id="{A0206C53-62BD-3740-D530-981DF9FA9D9B}"/>
              </a:ext>
            </a:extLst>
          </p:cNvPr>
          <p:cNvSpPr/>
          <p:nvPr/>
        </p:nvSpPr>
        <p:spPr>
          <a:xfrm>
            <a:off x="1331143" y="5159910"/>
            <a:ext cx="640080" cy="296503"/>
          </a:xfrm>
          <a:prstGeom prst="rect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13D59EA-9A16-6527-B905-4B29DCF4ABF6}"/>
              </a:ext>
            </a:extLst>
          </p:cNvPr>
          <p:cNvSpPr txBox="1"/>
          <p:nvPr/>
        </p:nvSpPr>
        <p:spPr>
          <a:xfrm>
            <a:off x="5635769" y="6288040"/>
            <a:ext cx="4952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Western Blot picture for Fig. 6e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315155" y="281116"/>
            <a:ext cx="9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6h</a:t>
            </a:r>
          </a:p>
        </p:txBody>
      </p:sp>
      <p:pic>
        <p:nvPicPr>
          <p:cNvPr id="2" name="Picture 1" descr="Calendar&#10;&#10;Description automatically generated">
            <a:extLst>
              <a:ext uri="{FF2B5EF4-FFF2-40B4-BE49-F238E27FC236}">
                <a16:creationId xmlns:a16="http://schemas.microsoft.com/office/drawing/2014/main" id="{8283B286-0532-5647-100F-E57C33CF3F6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65" b="75464"/>
          <a:stretch/>
        </p:blipFill>
        <p:spPr>
          <a:xfrm>
            <a:off x="6176681" y="3207170"/>
            <a:ext cx="4778189" cy="2511905"/>
          </a:xfrm>
          <a:prstGeom prst="rect">
            <a:avLst/>
          </a:prstGeom>
        </p:spPr>
      </p:pic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DF6051C7-ED0B-33FE-E135-7C432CE39738}"/>
              </a:ext>
            </a:extLst>
          </p:cNvPr>
          <p:cNvCxnSpPr>
            <a:cxnSpLocks/>
          </p:cNvCxnSpPr>
          <p:nvPr/>
        </p:nvCxnSpPr>
        <p:spPr>
          <a:xfrm>
            <a:off x="3396892" y="2618012"/>
            <a:ext cx="2618428" cy="1536471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Rectangle 39">
            <a:extLst>
              <a:ext uri="{FF2B5EF4-FFF2-40B4-BE49-F238E27FC236}">
                <a16:creationId xmlns:a16="http://schemas.microsoft.com/office/drawing/2014/main" id="{705F120F-D8B4-38A9-D23D-0E2924F004CF}"/>
              </a:ext>
            </a:extLst>
          </p:cNvPr>
          <p:cNvSpPr/>
          <p:nvPr/>
        </p:nvSpPr>
        <p:spPr>
          <a:xfrm>
            <a:off x="6983661" y="4558260"/>
            <a:ext cx="548640" cy="27432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7" name="Picture 46" descr="Calendar&#10;&#10;Description automatically generated">
            <a:extLst>
              <a:ext uri="{FF2B5EF4-FFF2-40B4-BE49-F238E27FC236}">
                <a16:creationId xmlns:a16="http://schemas.microsoft.com/office/drawing/2014/main" id="{37C626B8-9647-A9AD-E73D-CE0E147DD86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52" t="44161" b="30933"/>
          <a:stretch/>
        </p:blipFill>
        <p:spPr>
          <a:xfrm>
            <a:off x="6015320" y="-44927"/>
            <a:ext cx="5717737" cy="3138426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0AB13D2B-830C-0B57-CF1D-9EEC158FF511}"/>
              </a:ext>
            </a:extLst>
          </p:cNvPr>
          <p:cNvGrpSpPr/>
          <p:nvPr/>
        </p:nvGrpSpPr>
        <p:grpSpPr>
          <a:xfrm>
            <a:off x="214613" y="1227216"/>
            <a:ext cx="3605531" cy="1657225"/>
            <a:chOff x="214613" y="1227216"/>
            <a:chExt cx="3605531" cy="1657225"/>
          </a:xfrm>
        </p:grpSpPr>
        <p:pic>
          <p:nvPicPr>
            <p:cNvPr id="8" name="Picture 2" descr="C:\Users\bcmhxx\Desktop\img226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853" t="13284" r="45338" b="84225"/>
            <a:stretch>
              <a:fillRect/>
            </a:stretch>
          </p:blipFill>
          <p:spPr bwMode="auto">
            <a:xfrm>
              <a:off x="1128109" y="2352177"/>
              <a:ext cx="1193509" cy="41438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2454064" y="2334186"/>
              <a:ext cx="1143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2454064" y="1655940"/>
              <a:ext cx="136608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egrin </a:t>
              </a:r>
              <a:r>
                <a:rPr lang="el-GR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l-GR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029925" y="1233746"/>
              <a:ext cx="17841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U87   </a:t>
              </a:r>
              <a:r>
                <a:rPr lang="en-US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GC</a:t>
              </a:r>
              <a:r>
                <a:rPr lang="el-GR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754948" y="2389417"/>
              <a:ext cx="2324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763248" y="2703518"/>
              <a:ext cx="2324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244798" y="2173393"/>
              <a:ext cx="4810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55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43486" y="2515109"/>
              <a:ext cx="4823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42</a:t>
              </a:r>
            </a:p>
          </p:txBody>
        </p:sp>
        <p:cxnSp>
          <p:nvCxnSpPr>
            <p:cNvPr id="34" name="Straight Connector 33"/>
            <p:cNvCxnSpPr/>
            <p:nvPr/>
          </p:nvCxnSpPr>
          <p:spPr>
            <a:xfrm>
              <a:off x="754948" y="1695406"/>
              <a:ext cx="2324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214613" y="1524286"/>
              <a:ext cx="6402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140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20964" y="1227216"/>
              <a:ext cx="6402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err="1"/>
                <a:t>kDa</a:t>
              </a:r>
              <a:endParaRPr lang="en-US" b="1" dirty="0"/>
            </a:p>
          </p:txBody>
        </p:sp>
        <p:pic>
          <p:nvPicPr>
            <p:cNvPr id="48" name="Picture 47" descr="Calendar&#10;&#10;Description automatically generated">
              <a:extLst>
                <a:ext uri="{FF2B5EF4-FFF2-40B4-BE49-F238E27FC236}">
                  <a16:creationId xmlns:a16="http://schemas.microsoft.com/office/drawing/2014/main" id="{62F55E8E-7B51-2CD3-F9AA-BCBDBBB59D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231" t="60590" r="35448" b="36619"/>
            <a:stretch/>
          </p:blipFill>
          <p:spPr>
            <a:xfrm>
              <a:off x="1123959" y="1603078"/>
              <a:ext cx="1193509" cy="491457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</p:grp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3484B039-B928-A098-D298-3A38EE01EAA0}"/>
              </a:ext>
            </a:extLst>
          </p:cNvPr>
          <p:cNvCxnSpPr>
            <a:cxnSpLocks/>
          </p:cNvCxnSpPr>
          <p:nvPr/>
        </p:nvCxnSpPr>
        <p:spPr>
          <a:xfrm>
            <a:off x="3860191" y="1836073"/>
            <a:ext cx="1931009" cy="0"/>
          </a:xfrm>
          <a:prstGeom prst="straightConnector1">
            <a:avLst/>
          </a:prstGeom>
          <a:ln w="25400">
            <a:solidFill>
              <a:srgbClr val="FFFF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B4F2C33D-D6FD-3A22-6FA2-B57E3A9BAD94}"/>
              </a:ext>
            </a:extLst>
          </p:cNvPr>
          <p:cNvSpPr/>
          <p:nvPr/>
        </p:nvSpPr>
        <p:spPr>
          <a:xfrm>
            <a:off x="7744501" y="2025272"/>
            <a:ext cx="718170" cy="369332"/>
          </a:xfrm>
          <a:prstGeom prst="rect">
            <a:avLst/>
          </a:prstGeom>
          <a:noFill/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6EE460B-1F8B-8C85-DC20-6F46E19B482A}"/>
              </a:ext>
            </a:extLst>
          </p:cNvPr>
          <p:cNvSpPr txBox="1"/>
          <p:nvPr/>
        </p:nvSpPr>
        <p:spPr>
          <a:xfrm>
            <a:off x="5635769" y="6288040"/>
            <a:ext cx="4952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Western Blot picture for Fig. 6h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</TotalTime>
  <Words>138</Words>
  <Application>Microsoft Office PowerPoint</Application>
  <PresentationFormat>Widescreen</PresentationFormat>
  <Paragraphs>50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ijie xiao</dc:creator>
  <cp:lastModifiedBy>Bian, Ka</cp:lastModifiedBy>
  <cp:revision>6</cp:revision>
  <dcterms:created xsi:type="dcterms:W3CDTF">2023-01-17T02:27:06Z</dcterms:created>
  <dcterms:modified xsi:type="dcterms:W3CDTF">2023-02-02T16:51:09Z</dcterms:modified>
</cp:coreProperties>
</file>